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87" r:id="rId2"/>
    <p:sldId id="289" r:id="rId3"/>
    <p:sldId id="290" r:id="rId4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64" userDrawn="1">
          <p15:clr>
            <a:srgbClr val="A4A3A4"/>
          </p15:clr>
        </p15:guide>
        <p15:guide id="2" pos="44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974" autoAdjust="0"/>
    <p:restoredTop sz="91667" autoAdjust="0"/>
  </p:normalViewPr>
  <p:slideViewPr>
    <p:cSldViewPr snapToGrid="0" showGuides="1">
      <p:cViewPr varScale="1">
        <p:scale>
          <a:sx n="44" d="100"/>
          <a:sy n="44" d="100"/>
        </p:scale>
        <p:origin x="1938" y="72"/>
      </p:cViewPr>
      <p:guideLst>
        <p:guide orient="horz" pos="3264"/>
        <p:guide pos="44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elis Sanchez" userId="75bdb5d600d0f49f" providerId="LiveId" clId="{2C240276-6EB7-41A4-94F9-7BB0A9D8B699}"/>
    <pc:docChg chg="modSld">
      <pc:chgData name="Annelis Sanchez" userId="75bdb5d600d0f49f" providerId="LiveId" clId="{2C240276-6EB7-41A4-94F9-7BB0A9D8B699}" dt="2023-08-18T13:58:21.193" v="0" actId="20577"/>
      <pc:docMkLst>
        <pc:docMk/>
      </pc:docMkLst>
      <pc:sldChg chg="modSp mod">
        <pc:chgData name="Annelis Sanchez" userId="75bdb5d600d0f49f" providerId="LiveId" clId="{2C240276-6EB7-41A4-94F9-7BB0A9D8B699}" dt="2023-08-18T13:58:21.193" v="0" actId="20577"/>
        <pc:sldMkLst>
          <pc:docMk/>
          <pc:sldMk cId="2684531526" sldId="289"/>
        </pc:sldMkLst>
        <pc:spChg chg="mod">
          <ac:chgData name="Annelis Sanchez" userId="75bdb5d600d0f49f" providerId="LiveId" clId="{2C240276-6EB7-41A4-94F9-7BB0A9D8B699}" dt="2023-08-18T13:58:21.193" v="0" actId="20577"/>
          <ac:spMkLst>
            <pc:docMk/>
            <pc:sldMk cId="2684531526" sldId="289"/>
            <ac:spMk id="2" creationId="{00000000-0000-0000-0000-000000000000}"/>
          </ac:spMkLst>
        </pc:spChg>
      </pc:sldChg>
    </pc:docChg>
  </pc:docChgLst>
  <pc:docChgLst>
    <pc:chgData name="Nilmary Grafals" userId="274a7034b8b93a94" providerId="LiveId" clId="{393266F3-099B-4A94-AAC5-183EB8C61B30}"/>
    <pc:docChg chg="undo custSel modSld">
      <pc:chgData name="Nilmary Grafals" userId="274a7034b8b93a94" providerId="LiveId" clId="{393266F3-099B-4A94-AAC5-183EB8C61B30}" dt="2023-02-14T21:59:41.698" v="9"/>
      <pc:docMkLst>
        <pc:docMk/>
      </pc:docMkLst>
      <pc:sldChg chg="addSp delSp modSp mod">
        <pc:chgData name="Nilmary Grafals" userId="274a7034b8b93a94" providerId="LiveId" clId="{393266F3-099B-4A94-AAC5-183EB8C61B30}" dt="2023-02-14T21:33:40.898" v="6" actId="478"/>
        <pc:sldMkLst>
          <pc:docMk/>
          <pc:sldMk cId="3900744495" sldId="277"/>
        </pc:sldMkLst>
        <pc:spChg chg="mod">
          <ac:chgData name="Nilmary Grafals" userId="274a7034b8b93a94" providerId="LiveId" clId="{393266F3-099B-4A94-AAC5-183EB8C61B30}" dt="2023-02-14T21:33:40.029" v="5" actId="20577"/>
          <ac:spMkLst>
            <pc:docMk/>
            <pc:sldMk cId="3900744495" sldId="277"/>
            <ac:spMk id="9" creationId="{6CA4BB56-9D31-59C6-281B-AF3AE7B2BEDF}"/>
          </ac:spMkLst>
        </pc:spChg>
        <pc:spChg chg="add del mod">
          <ac:chgData name="Nilmary Grafals" userId="274a7034b8b93a94" providerId="LiveId" clId="{393266F3-099B-4A94-AAC5-183EB8C61B30}" dt="2023-02-14T21:33:40.898" v="6" actId="478"/>
          <ac:spMkLst>
            <pc:docMk/>
            <pc:sldMk cId="3900744495" sldId="277"/>
            <ac:spMk id="28" creationId="{766AE58C-2BD0-242D-2D4A-AB502E4C7191}"/>
          </ac:spMkLst>
        </pc:spChg>
      </pc:sldChg>
      <pc:sldChg chg="modSp">
        <pc:chgData name="Nilmary Grafals" userId="274a7034b8b93a94" providerId="LiveId" clId="{393266F3-099B-4A94-AAC5-183EB8C61B30}" dt="2023-02-14T21:59:41.698" v="9"/>
        <pc:sldMkLst>
          <pc:docMk/>
          <pc:sldMk cId="2059535690" sldId="283"/>
        </pc:sldMkLst>
        <pc:graphicFrameChg chg="mod">
          <ac:chgData name="Nilmary Grafals" userId="274a7034b8b93a94" providerId="LiveId" clId="{393266F3-099B-4A94-AAC5-183EB8C61B30}" dt="2023-02-14T21:59:41.698" v="9"/>
          <ac:graphicFrameMkLst>
            <pc:docMk/>
            <pc:sldMk cId="2059535690" sldId="283"/>
            <ac:graphicFrameMk id="50" creationId="{C87D6710-4F50-5767-5056-B6D4018C258F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317C2-1AA1-4AA9-8114-6AEAF3C2822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A72B70-BFB8-4F10-BFCF-6EEBAEBD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039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146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945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00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202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621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133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070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957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553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460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841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DAFBC-697C-4AD6-A68E-253BFB802789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FDCDB-AA90-4977-981D-B324B8798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75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860240"/>
              </p:ext>
            </p:extLst>
          </p:nvPr>
        </p:nvGraphicFramePr>
        <p:xfrm>
          <a:off x="471450" y="2837976"/>
          <a:ext cx="6668854" cy="27432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99811">
                  <a:extLst>
                    <a:ext uri="{9D8B030D-6E8A-4147-A177-3AD203B41FA5}">
                      <a16:colId xmlns:a16="http://schemas.microsoft.com/office/drawing/2014/main" val="1679321653"/>
                    </a:ext>
                  </a:extLst>
                </a:gridCol>
                <a:gridCol w="1070811">
                  <a:extLst>
                    <a:ext uri="{9D8B030D-6E8A-4147-A177-3AD203B41FA5}">
                      <a16:colId xmlns:a16="http://schemas.microsoft.com/office/drawing/2014/main" val="616234611"/>
                    </a:ext>
                  </a:extLst>
                </a:gridCol>
                <a:gridCol w="830179">
                  <a:extLst>
                    <a:ext uri="{9D8B030D-6E8A-4147-A177-3AD203B41FA5}">
                      <a16:colId xmlns:a16="http://schemas.microsoft.com/office/drawing/2014/main" val="72640491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395315162"/>
                    </a:ext>
                  </a:extLst>
                </a:gridCol>
                <a:gridCol w="926431">
                  <a:extLst>
                    <a:ext uri="{9D8B030D-6E8A-4147-A177-3AD203B41FA5}">
                      <a16:colId xmlns:a16="http://schemas.microsoft.com/office/drawing/2014/main" val="3327383909"/>
                    </a:ext>
                  </a:extLst>
                </a:gridCol>
                <a:gridCol w="1227222">
                  <a:extLst>
                    <a:ext uri="{9D8B030D-6E8A-4147-A177-3AD203B41FA5}">
                      <a16:colId xmlns:a16="http://schemas.microsoft.com/office/drawing/2014/main" val="30433467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Database</a:t>
                      </a:r>
                    </a:p>
                    <a:p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etScan</a:t>
                      </a:r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DB</a:t>
                      </a:r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walk</a:t>
                      </a:r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naT</a:t>
                      </a:r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Tarbase</a:t>
                      </a:r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575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XW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46625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93495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D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18319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KK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20407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8411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1382186"/>
                  </a:ext>
                </a:extLst>
              </a:tr>
            </a:tbl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471450" y="2837976"/>
            <a:ext cx="1687780" cy="52404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71450" y="1487976"/>
            <a:ext cx="67715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Priority of the prediction in each of the databases for the miR-92b target genes reported in GBMs.</a:t>
            </a:r>
          </a:p>
        </p:txBody>
      </p:sp>
    </p:spTree>
    <p:extLst>
      <p:ext uri="{BB962C8B-B14F-4D97-AF65-F5344CB8AC3E}">
        <p14:creationId xmlns:p14="http://schemas.microsoft.com/office/powerpoint/2010/main" val="4075047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5767" y="2274841"/>
            <a:ext cx="4762500" cy="395287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15351" y="641445"/>
            <a:ext cx="69680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Venn diagram showing the common miR-92b (3p) target genes shared by the four miRNA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predicted softwar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4531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7045" y="435384"/>
            <a:ext cx="69581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FBXW7 expression in brain tumors in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lioVi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using the Rembrandt database: Platform: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ffymetri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HG U133 v2.0 Plus.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1455790" y="5901301"/>
            <a:ext cx="4358570" cy="2996517"/>
            <a:chOff x="1284996" y="2113496"/>
            <a:chExt cx="4358570" cy="299651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7784818-494E-43E9-88A0-57796B9BCC1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84996" y="2113496"/>
              <a:ext cx="4358570" cy="2996517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860744" y="3032280"/>
              <a:ext cx="2743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-value long rank test= 0.0228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029155" y="1870873"/>
            <a:ext cx="5053963" cy="3060233"/>
            <a:chOff x="1284996" y="5714210"/>
            <a:chExt cx="5053963" cy="30602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AEECC17-1904-4F70-9D9C-B5336DABE3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907"/>
            <a:stretch/>
          </p:blipFill>
          <p:spPr>
            <a:xfrm>
              <a:off x="1284996" y="5714210"/>
              <a:ext cx="5053963" cy="306023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510159" y="5874908"/>
              <a:ext cx="15600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ova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: p=3.0e-5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584708" y="1699592"/>
            <a:ext cx="351378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37509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6</TotalTime>
  <Words>128</Words>
  <Application>Microsoft Office PowerPoint</Application>
  <PresentationFormat>Custom</PresentationFormat>
  <Paragraphs>6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figures</dc:title>
  <dc:creator>Nilmary Grafals</dc:creator>
  <cp:lastModifiedBy>Annelis O  Sanchez Alvarez</cp:lastModifiedBy>
  <cp:revision>74</cp:revision>
  <cp:lastPrinted>2023-04-05T12:04:06Z</cp:lastPrinted>
  <dcterms:created xsi:type="dcterms:W3CDTF">2020-04-14T17:43:27Z</dcterms:created>
  <dcterms:modified xsi:type="dcterms:W3CDTF">2023-08-18T13:58:30Z</dcterms:modified>
</cp:coreProperties>
</file>